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0F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68" autoAdjust="0"/>
    <p:restoredTop sz="94660"/>
  </p:normalViewPr>
  <p:slideViewPr>
    <p:cSldViewPr snapToGrid="0">
      <p:cViewPr varScale="1">
        <p:scale>
          <a:sx n="47" d="100"/>
          <a:sy n="47" d="100"/>
        </p:scale>
        <p:origin x="2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15862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76016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1365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9011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69988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1831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7812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10167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2341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9500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92728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5082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609600" y="161925"/>
            <a:ext cx="10744200" cy="723900"/>
          </a:xfrm>
        </p:spPr>
        <p:txBody>
          <a:bodyPr>
            <a:normAutofit/>
          </a:bodyPr>
          <a:lstStyle/>
          <a:p>
            <a:r>
              <a:rPr lang="en-US" altLang="zh-TW" sz="2000" b="1" dirty="0">
                <a:latin typeface="+mn-lt"/>
              </a:rPr>
              <a:t>Supplement </a:t>
            </a:r>
            <a:r>
              <a:rPr lang="en-US" altLang="zh-TW" sz="2000" b="1">
                <a:latin typeface="+mn-lt"/>
              </a:rPr>
              <a:t>Table S1</a:t>
            </a:r>
            <a:r>
              <a:rPr lang="en-US" altLang="zh-TW" sz="2000" b="1" dirty="0">
                <a:latin typeface="+mn-lt"/>
              </a:rPr>
              <a:t>. </a:t>
            </a:r>
            <a:r>
              <a:rPr lang="en-US" altLang="zh-TW" sz="2000" dirty="0">
                <a:latin typeface="+mn-lt"/>
              </a:rPr>
              <a:t>Five-year risk analysis of outcomes in non-anemic female patients with stage 3 chronic kidney disease, comparing those who received iron therapy versus those who did not.</a:t>
            </a:r>
            <a:endParaRPr lang="zh-TW" altLang="en-US" sz="2000" dirty="0">
              <a:latin typeface="+mn-lt"/>
            </a:endParaRPr>
          </a:p>
        </p:txBody>
      </p:sp>
      <p:graphicFrame>
        <p:nvGraphicFramePr>
          <p:cNvPr id="4" name="內容版面配置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727116484"/>
              </p:ext>
            </p:extLst>
          </p:nvPr>
        </p:nvGraphicFramePr>
        <p:xfrm>
          <a:off x="609600" y="885825"/>
          <a:ext cx="10972800" cy="58863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200">
                  <a:extLst>
                    <a:ext uri="{9D8B030D-6E8A-4147-A177-3AD203B41FA5}">
                      <a16:colId xmlns:a16="http://schemas.microsoft.com/office/drawing/2014/main" val="260973184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13277275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985075950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1810906543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30662162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1068371023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3936916432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308669869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404336728"/>
                    </a:ext>
                  </a:extLst>
                </a:gridCol>
              </a:tblGrid>
              <a:tr h="427181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Outcomes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Cohorts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Patients </a:t>
                      </a:r>
                    </a:p>
                    <a:p>
                      <a:pPr algn="ctr"/>
                      <a:r>
                        <a:rPr lang="en-US" altLang="zh-TW" sz="1400" dirty="0"/>
                        <a:t>in cohort</a:t>
                      </a:r>
                      <a:endParaRPr lang="zh-TW" altLang="en-US" sz="1400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 Patients </a:t>
                      </a:r>
                      <a:r>
                        <a:rPr lang="en-US" altLang="zh-TW" sz="1400" dirty="0"/>
                        <a:t>with outcome</a:t>
                      </a:r>
                      <a:endParaRPr lang="zh-TW" altLang="en-US" sz="1400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Risk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Risk Difference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Risk Ratio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Odds Ratio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/>
                        <a:t>P value</a:t>
                      </a:r>
                      <a:endParaRPr lang="zh-TW" altLang="en-US" dirty="0"/>
                    </a:p>
                  </a:txBody>
                  <a:tcPr anchor="ctr">
                    <a:solidFill>
                      <a:srgbClr val="2A0F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2531891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All-cause mortality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457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38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21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-0.001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949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94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656</a:t>
                      </a:r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27430814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438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45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23</a:t>
                      </a:r>
                      <a:endParaRPr lang="zh-TW" altLang="en-US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6387252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MACE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5060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153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22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54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30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389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00</a:t>
                      </a:r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12541005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5364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934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174</a:t>
                      </a:r>
                      <a:endParaRPr lang="zh-TW" altLang="en-US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4585709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AKI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451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574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89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3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741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813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00</a:t>
                      </a:r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17424421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514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333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51</a:t>
                      </a:r>
                      <a:endParaRPr lang="zh-TW" altLang="en-US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5933201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Pneumonia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282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419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67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22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509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545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altLang="zh-TW" b="1" dirty="0"/>
                    </a:p>
                    <a:p>
                      <a:pPr algn="ctr"/>
                      <a:r>
                        <a:rPr lang="en-US" altLang="zh-TW" b="1" dirty="0"/>
                        <a:t>0.000</a:t>
                      </a:r>
                    </a:p>
                    <a:p>
                      <a:pPr algn="ctr"/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60069175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357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281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44</a:t>
                      </a:r>
                      <a:endParaRPr lang="zh-TW" altLang="en-US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2520815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GFR &lt; 30 ml/min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294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03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96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2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414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458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altLang="zh-TW" b="1" dirty="0"/>
                    </a:p>
                    <a:p>
                      <a:pPr algn="ctr"/>
                      <a:r>
                        <a:rPr lang="en-US" altLang="zh-TW" b="1" dirty="0"/>
                        <a:t>0.000</a:t>
                      </a:r>
                    </a:p>
                    <a:p>
                      <a:pPr algn="ctr"/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31751697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361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431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68</a:t>
                      </a:r>
                      <a:endParaRPr lang="zh-TW" altLang="en-US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3879595"/>
                  </a:ext>
                </a:extLst>
              </a:tr>
              <a:tr h="427181">
                <a:tc rowSpan="2">
                  <a:txBody>
                    <a:bodyPr/>
                    <a:lstStyle/>
                    <a:p>
                      <a:r>
                        <a:rPr lang="en-US" altLang="zh-TW" sz="1400" b="1" dirty="0"/>
                        <a:t>GI bleeding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+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210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529</a:t>
                      </a:r>
                      <a:endParaRPr lang="zh-TW" altLang="en-US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85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33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647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1.707</a:t>
                      </a:r>
                      <a:endParaRPr lang="zh-TW" altLang="en-US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00</a:t>
                      </a:r>
                    </a:p>
                    <a:p>
                      <a:pPr algn="ctr"/>
                      <a:endParaRPr lang="zh-TW" altLang="en-US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6487854"/>
                  </a:ext>
                </a:extLst>
              </a:tr>
              <a:tr h="427181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/>
                        <a:t>- iron</a:t>
                      </a:r>
                      <a:endParaRPr lang="zh-TW" alt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6264</a:t>
                      </a:r>
                      <a:endParaRPr lang="zh-TW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324</a:t>
                      </a:r>
                      <a:endParaRPr lang="zh-TW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b="1" dirty="0"/>
                        <a:t>0.052</a:t>
                      </a:r>
                      <a:endParaRPr lang="zh-TW" altLang="en-US" b="1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14755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3891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48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upplement Table S1. Five-year risk analysis of outcomes in non-anemic female patients with stage 3 chronic kidney disease, comparing those who received iron therapy versus those who did not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Kuo-Cheng</dc:creator>
  <cp:lastModifiedBy>MDPI</cp:lastModifiedBy>
  <cp:revision>5</cp:revision>
  <dcterms:created xsi:type="dcterms:W3CDTF">2025-05-24T08:40:56Z</dcterms:created>
  <dcterms:modified xsi:type="dcterms:W3CDTF">2025-08-07T10:01:36Z</dcterms:modified>
</cp:coreProperties>
</file>